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94BDD-D3C8-43E7-B95A-3F21073B88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C09F2-725E-40CF-82E3-AED7014983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D37B6-2C4A-4DB7-9A99-3983AE505E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84641-5EB5-41CA-98AE-628BAE4CC7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44956-5C7A-436F-8F55-A4D1BA4BA2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6685F8-B3F9-438B-B0CB-CF2BCD9236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D6071-6EFE-42D7-A3D6-2E00BFE87F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47AA5-4692-49B3-B4FD-A4725007FB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7A662-D60C-42A2-89B3-2FCF8D0954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11FA2-F665-4714-B768-A83CA8029D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DEDD3-B5DD-4306-BEC5-EBED5808EA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25E3E-5107-4113-86E6-1C0C2179C6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C51A55-A61E-4275-9460-B090A0F0B36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6072120" y="3080880"/>
            <a:ext cx="2500560" cy="186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000000"/>
                </a:solidFill>
                <a:latin typeface="Calibri"/>
                <a:ea typeface="Times New Roman"/>
              </a:rPr>
              <a:t>}</a:t>
            </a: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PCR products in the expected ranges for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WD008 – 164 bp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WD036 – 230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WD103 – 167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(WD120 – 240 bp, additional methylase candidat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6"/>
          <p:cNvSpPr/>
          <p:nvPr/>
        </p:nvSpPr>
        <p:spPr>
          <a:xfrm rot="10800000">
            <a:off x="523080" y="2215800"/>
            <a:ext cx="36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Symbol"/>
                <a:ea typeface="Symbol"/>
              </a:rPr>
              <a:t>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8"/>
          <p:cNvSpPr/>
          <p:nvPr/>
        </p:nvSpPr>
        <p:spPr>
          <a:xfrm rot="10800000">
            <a:off x="499680" y="3002040"/>
            <a:ext cx="41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Symbol"/>
                <a:ea typeface="Symbol"/>
              </a:rPr>
              <a:t>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20"/>
          <p:cNvSpPr/>
          <p:nvPr/>
        </p:nvSpPr>
        <p:spPr>
          <a:xfrm>
            <a:off x="2520" y="3214800"/>
            <a:ext cx="61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200 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1"/>
          <p:cNvSpPr/>
          <p:nvPr/>
        </p:nvSpPr>
        <p:spPr>
          <a:xfrm>
            <a:off x="2520" y="3000240"/>
            <a:ext cx="61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500 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23"/>
          <p:cNvSpPr/>
          <p:nvPr/>
        </p:nvSpPr>
        <p:spPr>
          <a:xfrm>
            <a:off x="2160" y="2214720"/>
            <a:ext cx="52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1 k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4"/>
          <p:cNvSpPr/>
          <p:nvPr/>
        </p:nvSpPr>
        <p:spPr>
          <a:xfrm>
            <a:off x="2880" y="1857240"/>
            <a:ext cx="104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100 bp ladd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071720" y="2286000"/>
            <a:ext cx="4898880" cy="2381400"/>
          </a:xfrm>
          <a:prstGeom prst="rect">
            <a:avLst/>
          </a:prstGeom>
          <a:ln w="0">
            <a:noFill/>
          </a:ln>
        </p:spPr>
      </p:pic>
      <p:sp>
        <p:nvSpPr>
          <p:cNvPr id="49" name="TextBox 12"/>
          <p:cNvSpPr/>
          <p:nvPr/>
        </p:nvSpPr>
        <p:spPr>
          <a:xfrm>
            <a:off x="357120" y="50004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4"/>
          <p:cNvSpPr/>
          <p:nvPr/>
        </p:nvSpPr>
        <p:spPr>
          <a:xfrm rot="16200000">
            <a:off x="2286000" y="4363920"/>
            <a:ext cx="8712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0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10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0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1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5"/>
          <p:cNvSpPr/>
          <p:nvPr/>
        </p:nvSpPr>
        <p:spPr>
          <a:xfrm rot="16200000">
            <a:off x="4500360" y="4363920"/>
            <a:ext cx="8712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0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10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0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D1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6"/>
          <p:cNvSpPr/>
          <p:nvPr/>
        </p:nvSpPr>
        <p:spPr>
          <a:xfrm rot="10800000">
            <a:off x="523080" y="3215880"/>
            <a:ext cx="36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Symbol"/>
                <a:ea typeface="Symbol"/>
              </a:rPr>
              <a:t>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eft-Right Arrow 17"/>
          <p:cNvSpPr/>
          <p:nvPr/>
        </p:nvSpPr>
        <p:spPr>
          <a:xfrm>
            <a:off x="1785960" y="5857920"/>
            <a:ext cx="1928880" cy="214200"/>
          </a:xfrm>
          <a:prstGeom prst="leftRightArrow">
            <a:avLst>
              <a:gd name="adj1" fmla="val 50000"/>
              <a:gd name="adj2" fmla="val 50028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eft-Right Arrow 18"/>
          <p:cNvSpPr/>
          <p:nvPr/>
        </p:nvSpPr>
        <p:spPr>
          <a:xfrm>
            <a:off x="4000680" y="5857920"/>
            <a:ext cx="1928520" cy="214200"/>
          </a:xfrm>
          <a:prstGeom prst="leftRightArrow">
            <a:avLst>
              <a:gd name="adj1" fmla="val 50000"/>
              <a:gd name="adj2" fmla="val 50019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9"/>
          <p:cNvSpPr/>
          <p:nvPr/>
        </p:nvSpPr>
        <p:spPr>
          <a:xfrm>
            <a:off x="1222560" y="6143760"/>
            <a:ext cx="2480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gDNA from cultur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Calibri"/>
              </a:rPr>
              <a:t>Symbiodinium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 (clade D1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0"/>
          <p:cNvSpPr/>
          <p:nvPr/>
        </p:nvSpPr>
        <p:spPr>
          <a:xfrm>
            <a:off x="4003920" y="6143760"/>
            <a:ext cx="2464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gDNA of coral sper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rom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</a:rPr>
              <a:t> Acropora millepor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3T15:02:59Z</dcterms:created>
  <dc:creator>Computer Unit</dc:creator>
  <dc:description/>
  <dc:language>en-US</dc:language>
  <cp:lastModifiedBy>plong</cp:lastModifiedBy>
  <dcterms:modified xsi:type="dcterms:W3CDTF">2010-10-27T10:32:01Z</dcterms:modified>
  <cp:revision>13</cp:revision>
  <dc:subject/>
  <dc:title>Slide 1</dc:title>
</cp:coreProperties>
</file>